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009200" cy="929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038400" cy="46512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970440" y="0"/>
            <a:ext cx="3038400" cy="46512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Arial"/>
                <a:ea typeface="宋体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3240" rIns="93240" tIns="46440" bIns="4644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C2760AA-2983-4127-964A-1B888AB64841}" type="slidenum">
              <a:rPr b="0" lang="zh-CN" sz="12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177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Calibri"/>
                <a:ea typeface="宋体"/>
              </a:rPr>
              <a:t>四个物种交叉的情况，重新作图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8" name="灯片编号占位符 3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5C9D6D9-72FD-4869-8796-4F92D58372E4}" type="slidenum">
              <a:rPr b="0" lang="zh-CN" sz="12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100BE8-1F9D-4A9B-9FD1-9DA34F1276D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69BCAF-35F6-42F7-9025-CA02837F1AB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14828E-D53A-489A-A872-58E99963CEC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547161-B90F-4D2B-B9EF-02E14C5E71B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408C54-024D-4B0B-B476-9CD2B8508F0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8913B6-C246-4753-90E8-3838BD4CB60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724FB3-407D-4611-BCBF-29C88E67CCA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67D8BA-AA7D-4897-934B-231EEE8CC39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A61468-79B4-4588-8E48-0DF29E540F9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4D00DE-D7CF-4A12-978C-1334B4F4CE4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9BA9C2-BC55-4DAE-A047-2B84EFB21AB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A07193-1FE5-4EA2-8297-D10BE78FF7E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  <a:ea typeface="宋体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  <a:ea typeface="宋体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114B80D-B72F-43E2-ABC6-9BCDCDCF813A}" type="slidenum">
              <a:rPr b="0" lang="en-US" sz="1200" spc="-1" strike="noStrike">
                <a:solidFill>
                  <a:srgbClr val="898989"/>
                </a:solidFill>
                <a:latin typeface="Calibri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91" descr=""/>
          <p:cNvPicPr/>
          <p:nvPr/>
        </p:nvPicPr>
        <p:blipFill>
          <a:blip r:embed="rId1"/>
          <a:stretch/>
        </p:blipFill>
        <p:spPr>
          <a:xfrm>
            <a:off x="4565520" y="3041640"/>
            <a:ext cx="2914920" cy="220680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90" descr=""/>
          <p:cNvPicPr/>
          <p:nvPr/>
        </p:nvPicPr>
        <p:blipFill>
          <a:blip r:embed="rId2"/>
          <a:stretch/>
        </p:blipFill>
        <p:spPr>
          <a:xfrm>
            <a:off x="1487520" y="3498840"/>
            <a:ext cx="2633760" cy="1755720"/>
          </a:xfrm>
          <a:prstGeom prst="rect">
            <a:avLst/>
          </a:prstGeom>
          <a:ln w="0">
            <a:noFill/>
          </a:ln>
        </p:spPr>
      </p:pic>
      <p:sp>
        <p:nvSpPr>
          <p:cNvPr id="50" name="矩形 4"/>
          <p:cNvSpPr/>
          <p:nvPr/>
        </p:nvSpPr>
        <p:spPr>
          <a:xfrm>
            <a:off x="0" y="0"/>
            <a:ext cx="914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Fig. S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1"/>
          <p:cNvSpPr/>
          <p:nvPr/>
        </p:nvSpPr>
        <p:spPr>
          <a:xfrm>
            <a:off x="6353280" y="3619440"/>
            <a:ext cx="99036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宋体"/>
              </a:rPr>
              <a:t>turquois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1"/>
          <p:cNvSpPr/>
          <p:nvPr/>
        </p:nvSpPr>
        <p:spPr>
          <a:xfrm>
            <a:off x="4876920" y="4648320"/>
            <a:ext cx="609480" cy="30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宋体"/>
              </a:rPr>
              <a:t>Brow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1"/>
          <p:cNvSpPr/>
          <p:nvPr/>
        </p:nvSpPr>
        <p:spPr>
          <a:xfrm>
            <a:off x="6172200" y="3809880"/>
            <a:ext cx="76212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宋体"/>
              </a:rPr>
              <a:t>darkgree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1"/>
          <p:cNvSpPr/>
          <p:nvPr/>
        </p:nvSpPr>
        <p:spPr>
          <a:xfrm>
            <a:off x="2941560" y="4800600"/>
            <a:ext cx="76212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Times New Roman"/>
                <a:ea typeface="宋体"/>
              </a:rPr>
              <a:t>royalblu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1"/>
          <p:cNvSpPr/>
          <p:nvPr/>
        </p:nvSpPr>
        <p:spPr>
          <a:xfrm>
            <a:off x="1569960" y="4038480"/>
            <a:ext cx="83844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Times New Roman"/>
                <a:ea typeface="宋体"/>
              </a:rPr>
              <a:t>lightyellow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1"/>
          <p:cNvSpPr/>
          <p:nvPr/>
        </p:nvSpPr>
        <p:spPr>
          <a:xfrm>
            <a:off x="1951200" y="4572000"/>
            <a:ext cx="63972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Times New Roman"/>
                <a:ea typeface="宋体"/>
              </a:rPr>
              <a:t>yellow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1"/>
          <p:cNvSpPr/>
          <p:nvPr/>
        </p:nvSpPr>
        <p:spPr>
          <a:xfrm>
            <a:off x="5105520" y="4419720"/>
            <a:ext cx="990360" cy="30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宋体"/>
              </a:rPr>
              <a:t>darkturquois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1"/>
          <p:cNvSpPr/>
          <p:nvPr/>
        </p:nvSpPr>
        <p:spPr>
          <a:xfrm>
            <a:off x="6705720" y="3352680"/>
            <a:ext cx="60948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宋体"/>
              </a:rPr>
              <a:t>whit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1"/>
          <p:cNvSpPr/>
          <p:nvPr/>
        </p:nvSpPr>
        <p:spPr>
          <a:xfrm>
            <a:off x="6705720" y="3200400"/>
            <a:ext cx="83808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宋体"/>
              </a:rPr>
              <a:t>pink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1"/>
          <p:cNvSpPr/>
          <p:nvPr/>
        </p:nvSpPr>
        <p:spPr>
          <a:xfrm>
            <a:off x="5867280" y="4038480"/>
            <a:ext cx="68580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宋体"/>
              </a:rPr>
              <a:t>purpl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Box 1"/>
          <p:cNvSpPr/>
          <p:nvPr/>
        </p:nvSpPr>
        <p:spPr>
          <a:xfrm>
            <a:off x="5486400" y="4191120"/>
            <a:ext cx="1143000" cy="30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宋体"/>
              </a:rPr>
              <a:t>midnightblu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1"/>
          <p:cNvSpPr/>
          <p:nvPr/>
        </p:nvSpPr>
        <p:spPr>
          <a:xfrm>
            <a:off x="2637000" y="3962520"/>
            <a:ext cx="609480" cy="30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Times New Roman"/>
                <a:ea typeface="宋体"/>
              </a:rPr>
              <a:t>grey6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1"/>
          <p:cNvSpPr/>
          <p:nvPr/>
        </p:nvSpPr>
        <p:spPr>
          <a:xfrm>
            <a:off x="2712960" y="4191120"/>
            <a:ext cx="838440" cy="30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Times New Roman"/>
                <a:ea typeface="宋体"/>
              </a:rPr>
              <a:t>brow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1"/>
          <p:cNvSpPr/>
          <p:nvPr/>
        </p:nvSpPr>
        <p:spPr>
          <a:xfrm>
            <a:off x="1646280" y="4343400"/>
            <a:ext cx="83808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Times New Roman"/>
                <a:ea typeface="宋体"/>
              </a:rPr>
              <a:t>greenyellow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1"/>
          <p:cNvSpPr/>
          <p:nvPr/>
        </p:nvSpPr>
        <p:spPr>
          <a:xfrm>
            <a:off x="1494000" y="3809880"/>
            <a:ext cx="76176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Times New Roman"/>
                <a:ea typeface="宋体"/>
              </a:rPr>
              <a:t>drakgree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1"/>
          <p:cNvSpPr/>
          <p:nvPr/>
        </p:nvSpPr>
        <p:spPr>
          <a:xfrm>
            <a:off x="3170160" y="4419720"/>
            <a:ext cx="533520" cy="30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Times New Roman"/>
                <a:ea typeface="宋体"/>
              </a:rPr>
              <a:t>gree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1"/>
          <p:cNvSpPr/>
          <p:nvPr/>
        </p:nvSpPr>
        <p:spPr>
          <a:xfrm>
            <a:off x="1569960" y="3581280"/>
            <a:ext cx="99072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Times New Roman"/>
                <a:ea typeface="宋体"/>
              </a:rPr>
              <a:t>midnightblu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1"/>
          <p:cNvSpPr/>
          <p:nvPr/>
        </p:nvSpPr>
        <p:spPr>
          <a:xfrm>
            <a:off x="2666880" y="4648320"/>
            <a:ext cx="487440" cy="30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Times New Roman"/>
                <a:ea typeface="宋体"/>
              </a:rPr>
              <a:t>black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Straight Connector 218"/>
          <p:cNvSpPr/>
          <p:nvPr/>
        </p:nvSpPr>
        <p:spPr>
          <a:xfrm flipH="1">
            <a:off x="2560680" y="3504600"/>
            <a:ext cx="4145040" cy="22860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Straight Connector 220"/>
          <p:cNvSpPr/>
          <p:nvPr/>
        </p:nvSpPr>
        <p:spPr>
          <a:xfrm flipH="1">
            <a:off x="2590920" y="3505320"/>
            <a:ext cx="4114800" cy="12189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Straight Connector 222"/>
          <p:cNvSpPr/>
          <p:nvPr/>
        </p:nvSpPr>
        <p:spPr>
          <a:xfrm flipH="1" flipV="1">
            <a:off x="2560320" y="3733920"/>
            <a:ext cx="3792600" cy="381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Straight Connector 224"/>
          <p:cNvSpPr/>
          <p:nvPr/>
        </p:nvSpPr>
        <p:spPr>
          <a:xfrm flipH="1">
            <a:off x="2590560" y="3771360"/>
            <a:ext cx="3762360" cy="95220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Straight Connector 226"/>
          <p:cNvSpPr/>
          <p:nvPr/>
        </p:nvSpPr>
        <p:spPr>
          <a:xfrm flipH="1">
            <a:off x="2484000" y="3772080"/>
            <a:ext cx="3868920" cy="72360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Straight Connector 228"/>
          <p:cNvSpPr/>
          <p:nvPr/>
        </p:nvSpPr>
        <p:spPr>
          <a:xfrm flipH="1">
            <a:off x="3551040" y="3771360"/>
            <a:ext cx="2801880" cy="57132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Straight Connector 230"/>
          <p:cNvSpPr/>
          <p:nvPr/>
        </p:nvSpPr>
        <p:spPr>
          <a:xfrm flipH="1">
            <a:off x="2408400" y="3772080"/>
            <a:ext cx="3944880" cy="41904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Straight Connector 232"/>
          <p:cNvSpPr/>
          <p:nvPr/>
        </p:nvSpPr>
        <p:spPr>
          <a:xfrm flipH="1">
            <a:off x="3703680" y="3772080"/>
            <a:ext cx="2649600" cy="79992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Straight Connector 234"/>
          <p:cNvSpPr/>
          <p:nvPr/>
        </p:nvSpPr>
        <p:spPr>
          <a:xfrm flipH="1">
            <a:off x="2484000" y="4191120"/>
            <a:ext cx="3382920" cy="3045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Straight Connector 236"/>
          <p:cNvSpPr/>
          <p:nvPr/>
        </p:nvSpPr>
        <p:spPr>
          <a:xfrm flipH="1">
            <a:off x="3551040" y="4190400"/>
            <a:ext cx="2315880" cy="15228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Straight Connector 238"/>
          <p:cNvSpPr/>
          <p:nvPr/>
        </p:nvSpPr>
        <p:spPr>
          <a:xfrm flipH="1">
            <a:off x="3703680" y="4191120"/>
            <a:ext cx="2163600" cy="7617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Straight Connector 240"/>
          <p:cNvSpPr/>
          <p:nvPr/>
        </p:nvSpPr>
        <p:spPr>
          <a:xfrm flipH="1">
            <a:off x="2590920" y="3352680"/>
            <a:ext cx="4114800" cy="137160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Straight Connector 242"/>
          <p:cNvSpPr/>
          <p:nvPr/>
        </p:nvSpPr>
        <p:spPr>
          <a:xfrm flipH="1">
            <a:off x="2484360" y="3351960"/>
            <a:ext cx="4221360" cy="114300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Straight Connector 244"/>
          <p:cNvSpPr/>
          <p:nvPr/>
        </p:nvSpPr>
        <p:spPr>
          <a:xfrm flipH="1" flipV="1">
            <a:off x="2560320" y="3733560"/>
            <a:ext cx="2925720" cy="60948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Straight Connector 246"/>
          <p:cNvSpPr/>
          <p:nvPr/>
        </p:nvSpPr>
        <p:spPr>
          <a:xfrm flipH="1">
            <a:off x="2484000" y="4342680"/>
            <a:ext cx="3002040" cy="15228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Straight Connector 248"/>
          <p:cNvSpPr/>
          <p:nvPr/>
        </p:nvSpPr>
        <p:spPr>
          <a:xfrm flipH="1">
            <a:off x="3703680" y="4342680"/>
            <a:ext cx="1782720" cy="60948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Straight Connector 250"/>
          <p:cNvSpPr/>
          <p:nvPr/>
        </p:nvSpPr>
        <p:spPr>
          <a:xfrm flipH="1" flipV="1">
            <a:off x="2255760" y="3962520"/>
            <a:ext cx="3230640" cy="38088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Straight Connector 252"/>
          <p:cNvSpPr/>
          <p:nvPr/>
        </p:nvSpPr>
        <p:spPr>
          <a:xfrm flipH="1" flipV="1">
            <a:off x="2560320" y="3733920"/>
            <a:ext cx="2544840" cy="83808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Straight Connector 254"/>
          <p:cNvSpPr/>
          <p:nvPr/>
        </p:nvSpPr>
        <p:spPr>
          <a:xfrm flipH="1">
            <a:off x="2590560" y="4571280"/>
            <a:ext cx="2514600" cy="15228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Straight Connector 256"/>
          <p:cNvSpPr/>
          <p:nvPr/>
        </p:nvSpPr>
        <p:spPr>
          <a:xfrm flipH="1" flipV="1">
            <a:off x="3551040" y="4343040"/>
            <a:ext cx="1554120" cy="22860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Straight Connector 258"/>
          <p:cNvSpPr/>
          <p:nvPr/>
        </p:nvSpPr>
        <p:spPr>
          <a:xfrm flipH="1">
            <a:off x="3154320" y="4571280"/>
            <a:ext cx="1951200" cy="22860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Straight Connector 260"/>
          <p:cNvSpPr/>
          <p:nvPr/>
        </p:nvSpPr>
        <p:spPr>
          <a:xfrm flipH="1" flipV="1">
            <a:off x="3246480" y="4114800"/>
            <a:ext cx="1859040" cy="45720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Straight Connector 262"/>
          <p:cNvSpPr/>
          <p:nvPr/>
        </p:nvSpPr>
        <p:spPr>
          <a:xfrm flipH="1">
            <a:off x="2590920" y="3962520"/>
            <a:ext cx="3581280" cy="7617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Straight Connector 265"/>
          <p:cNvSpPr/>
          <p:nvPr/>
        </p:nvSpPr>
        <p:spPr>
          <a:xfrm flipH="1">
            <a:off x="2484360" y="3961800"/>
            <a:ext cx="3687840" cy="5331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Straight Connector 267"/>
          <p:cNvSpPr/>
          <p:nvPr/>
        </p:nvSpPr>
        <p:spPr>
          <a:xfrm flipH="1">
            <a:off x="3551400" y="3962520"/>
            <a:ext cx="2620800" cy="38088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Straight Connector 269"/>
          <p:cNvSpPr/>
          <p:nvPr/>
        </p:nvSpPr>
        <p:spPr>
          <a:xfrm flipH="1">
            <a:off x="3153960" y="3962520"/>
            <a:ext cx="3017880" cy="83808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Straight Connector 271"/>
          <p:cNvSpPr/>
          <p:nvPr/>
        </p:nvSpPr>
        <p:spPr>
          <a:xfrm flipH="1" flipV="1">
            <a:off x="2560680" y="3733560"/>
            <a:ext cx="2316240" cy="106668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Straight Connector 273"/>
          <p:cNvSpPr/>
          <p:nvPr/>
        </p:nvSpPr>
        <p:spPr>
          <a:xfrm flipH="1" flipV="1">
            <a:off x="2590920" y="4724280"/>
            <a:ext cx="2286000" cy="7632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Straight Connector 275"/>
          <p:cNvSpPr/>
          <p:nvPr/>
        </p:nvSpPr>
        <p:spPr>
          <a:xfrm flipH="1" flipV="1">
            <a:off x="2484360" y="4495320"/>
            <a:ext cx="2392560" cy="30492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Straight Connector 277"/>
          <p:cNvSpPr/>
          <p:nvPr/>
        </p:nvSpPr>
        <p:spPr>
          <a:xfrm flipH="1" flipV="1">
            <a:off x="2255400" y="3962520"/>
            <a:ext cx="2621160" cy="83808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Straight Connector 279"/>
          <p:cNvSpPr/>
          <p:nvPr/>
        </p:nvSpPr>
        <p:spPr>
          <a:xfrm flipH="1">
            <a:off x="3153960" y="4800600"/>
            <a:ext cx="1722600" cy="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Rectangle 312"/>
          <p:cNvSpPr/>
          <p:nvPr/>
        </p:nvSpPr>
        <p:spPr>
          <a:xfrm>
            <a:off x="5338440" y="5116680"/>
            <a:ext cx="650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SYG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Rectangle 313"/>
          <p:cNvSpPr/>
          <p:nvPr/>
        </p:nvSpPr>
        <p:spPr>
          <a:xfrm>
            <a:off x="2113560" y="5116680"/>
            <a:ext cx="700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SYW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2" name="Picture 92" descr=""/>
          <p:cNvPicPr/>
          <p:nvPr/>
        </p:nvPicPr>
        <p:blipFill>
          <a:blip r:embed="rId3"/>
          <a:stretch/>
        </p:blipFill>
        <p:spPr>
          <a:xfrm>
            <a:off x="1444680" y="974880"/>
            <a:ext cx="2219400" cy="1854000"/>
          </a:xfrm>
          <a:prstGeom prst="rect">
            <a:avLst/>
          </a:prstGeom>
          <a:ln w="0">
            <a:noFill/>
          </a:ln>
        </p:spPr>
      </p:pic>
      <p:pic>
        <p:nvPicPr>
          <p:cNvPr id="103" name="Picture 83" descr="http://genome.jgi-psf.org/prom9/prochloro_mit9313.jpg"/>
          <p:cNvPicPr/>
          <p:nvPr/>
        </p:nvPicPr>
        <p:blipFill>
          <a:blip r:embed="rId4"/>
          <a:stretch/>
        </p:blipFill>
        <p:spPr>
          <a:xfrm>
            <a:off x="4108320" y="907920"/>
            <a:ext cx="2987640" cy="1994040"/>
          </a:xfrm>
          <a:prstGeom prst="rect">
            <a:avLst/>
          </a:prstGeom>
          <a:ln w="0">
            <a:noFill/>
          </a:ln>
        </p:spPr>
      </p:pic>
      <p:sp>
        <p:nvSpPr>
          <p:cNvPr id="104" name="Straight Connector 23"/>
          <p:cNvSpPr/>
          <p:nvPr/>
        </p:nvSpPr>
        <p:spPr>
          <a:xfrm flipH="1">
            <a:off x="2514600" y="1600200"/>
            <a:ext cx="3124080" cy="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Straight Connector 63"/>
          <p:cNvSpPr/>
          <p:nvPr/>
        </p:nvSpPr>
        <p:spPr>
          <a:xfrm flipH="1" flipV="1">
            <a:off x="2514240" y="1599840"/>
            <a:ext cx="3429000" cy="30492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TextBox 1"/>
          <p:cNvSpPr/>
          <p:nvPr/>
        </p:nvSpPr>
        <p:spPr>
          <a:xfrm>
            <a:off x="5638680" y="1447920"/>
            <a:ext cx="838440" cy="30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宋体"/>
              </a:rPr>
              <a:t>turquois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TextBox 1"/>
          <p:cNvSpPr/>
          <p:nvPr/>
        </p:nvSpPr>
        <p:spPr>
          <a:xfrm>
            <a:off x="1600200" y="1752480"/>
            <a:ext cx="76212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Times New Roman"/>
                <a:ea typeface="宋体"/>
              </a:rPr>
              <a:t>turquois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TextBox 1"/>
          <p:cNvSpPr/>
          <p:nvPr/>
        </p:nvSpPr>
        <p:spPr>
          <a:xfrm>
            <a:off x="1981080" y="1447920"/>
            <a:ext cx="533520" cy="30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Times New Roman"/>
                <a:ea typeface="宋体"/>
              </a:rPr>
              <a:t>cya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TextBox 1"/>
          <p:cNvSpPr/>
          <p:nvPr/>
        </p:nvSpPr>
        <p:spPr>
          <a:xfrm>
            <a:off x="2362320" y="2286000"/>
            <a:ext cx="45720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Times New Roman"/>
                <a:ea typeface="宋体"/>
              </a:rPr>
              <a:t>red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TextBox 1"/>
          <p:cNvSpPr/>
          <p:nvPr/>
        </p:nvSpPr>
        <p:spPr>
          <a:xfrm>
            <a:off x="1752480" y="2438280"/>
            <a:ext cx="68580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Times New Roman"/>
                <a:ea typeface="宋体"/>
              </a:rPr>
              <a:t>royalblu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Box 1"/>
          <p:cNvSpPr/>
          <p:nvPr/>
        </p:nvSpPr>
        <p:spPr>
          <a:xfrm>
            <a:off x="1523880" y="2057400"/>
            <a:ext cx="68580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Times New Roman"/>
                <a:ea typeface="宋体"/>
              </a:rPr>
              <a:t>magent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TextBox 1"/>
          <p:cNvSpPr/>
          <p:nvPr/>
        </p:nvSpPr>
        <p:spPr>
          <a:xfrm>
            <a:off x="2514600" y="1295280"/>
            <a:ext cx="53352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Times New Roman"/>
                <a:ea typeface="宋体"/>
              </a:rPr>
              <a:t>gree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TextBox 1"/>
          <p:cNvSpPr/>
          <p:nvPr/>
        </p:nvSpPr>
        <p:spPr>
          <a:xfrm>
            <a:off x="5105520" y="1295280"/>
            <a:ext cx="83808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宋体"/>
              </a:rPr>
              <a:t>purpl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TextBox 1"/>
          <p:cNvSpPr/>
          <p:nvPr/>
        </p:nvSpPr>
        <p:spPr>
          <a:xfrm>
            <a:off x="4952880" y="2209680"/>
            <a:ext cx="83844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宋体"/>
              </a:rPr>
              <a:t>black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TextBox 1"/>
          <p:cNvSpPr/>
          <p:nvPr/>
        </p:nvSpPr>
        <p:spPr>
          <a:xfrm>
            <a:off x="5943600" y="1752480"/>
            <a:ext cx="76212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宋体"/>
              </a:rPr>
              <a:t>pink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TextBox 1"/>
          <p:cNvSpPr/>
          <p:nvPr/>
        </p:nvSpPr>
        <p:spPr>
          <a:xfrm>
            <a:off x="5410080" y="2057400"/>
            <a:ext cx="114300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宋体"/>
              </a:rPr>
              <a:t>greenyellow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Straight Connector 17"/>
          <p:cNvSpPr/>
          <p:nvPr/>
        </p:nvSpPr>
        <p:spPr>
          <a:xfrm flipH="1" flipV="1">
            <a:off x="3048120" y="1447560"/>
            <a:ext cx="2590560" cy="15228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Straight Connector 19"/>
          <p:cNvSpPr/>
          <p:nvPr/>
        </p:nvSpPr>
        <p:spPr>
          <a:xfrm flipH="1">
            <a:off x="2361960" y="1599480"/>
            <a:ext cx="3276360" cy="30492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Straight Connector 25"/>
          <p:cNvSpPr/>
          <p:nvPr/>
        </p:nvSpPr>
        <p:spPr>
          <a:xfrm flipH="1">
            <a:off x="2590920" y="1599480"/>
            <a:ext cx="3047760" cy="68580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Straight Connector 27"/>
          <p:cNvSpPr/>
          <p:nvPr/>
        </p:nvSpPr>
        <p:spPr>
          <a:xfrm flipH="1">
            <a:off x="2209320" y="1599480"/>
            <a:ext cx="3429000" cy="60948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Straight Connector 29"/>
          <p:cNvSpPr/>
          <p:nvPr/>
        </p:nvSpPr>
        <p:spPr>
          <a:xfrm flipH="1" flipV="1">
            <a:off x="2362320" y="1905120"/>
            <a:ext cx="2590560" cy="45720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Straight Connector 31"/>
          <p:cNvSpPr/>
          <p:nvPr/>
        </p:nvSpPr>
        <p:spPr>
          <a:xfrm flipH="1" flipV="1">
            <a:off x="2514240" y="1599840"/>
            <a:ext cx="2438280" cy="76212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Straight Connector 33"/>
          <p:cNvSpPr/>
          <p:nvPr/>
        </p:nvSpPr>
        <p:spPr>
          <a:xfrm flipH="1" flipV="1">
            <a:off x="2590560" y="2286000"/>
            <a:ext cx="2361960" cy="7632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Straight Connector 35"/>
          <p:cNvSpPr/>
          <p:nvPr/>
        </p:nvSpPr>
        <p:spPr>
          <a:xfrm flipH="1" flipV="1">
            <a:off x="2362320" y="1905120"/>
            <a:ext cx="3047760" cy="3045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Straight Connector 37"/>
          <p:cNvSpPr/>
          <p:nvPr/>
        </p:nvSpPr>
        <p:spPr>
          <a:xfrm flipH="1" flipV="1">
            <a:off x="2514240" y="1599840"/>
            <a:ext cx="2895480" cy="60948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Straight Connector 39"/>
          <p:cNvSpPr/>
          <p:nvPr/>
        </p:nvSpPr>
        <p:spPr>
          <a:xfrm flipH="1">
            <a:off x="2590560" y="2209680"/>
            <a:ext cx="2819160" cy="7632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Straight Connector 41"/>
          <p:cNvSpPr/>
          <p:nvPr/>
        </p:nvSpPr>
        <p:spPr>
          <a:xfrm flipH="1">
            <a:off x="2437920" y="2208960"/>
            <a:ext cx="2971800" cy="38124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Straight Connector 43"/>
          <p:cNvSpPr/>
          <p:nvPr/>
        </p:nvSpPr>
        <p:spPr>
          <a:xfrm flipH="1">
            <a:off x="2209680" y="2209680"/>
            <a:ext cx="3200400" cy="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Straight Connector 45"/>
          <p:cNvSpPr/>
          <p:nvPr/>
        </p:nvSpPr>
        <p:spPr>
          <a:xfrm flipH="1" flipV="1">
            <a:off x="3047760" y="1447920"/>
            <a:ext cx="2361960" cy="7617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Straight Connector 61"/>
          <p:cNvSpPr/>
          <p:nvPr/>
        </p:nvSpPr>
        <p:spPr>
          <a:xfrm flipH="1">
            <a:off x="2362320" y="1905120"/>
            <a:ext cx="3581280" cy="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Straight Connector 67"/>
          <p:cNvSpPr/>
          <p:nvPr/>
        </p:nvSpPr>
        <p:spPr>
          <a:xfrm flipH="1">
            <a:off x="2362320" y="1447920"/>
            <a:ext cx="2743200" cy="45720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Straight Connector 69"/>
          <p:cNvSpPr/>
          <p:nvPr/>
        </p:nvSpPr>
        <p:spPr>
          <a:xfrm flipH="1">
            <a:off x="3047760" y="1447920"/>
            <a:ext cx="2057400" cy="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Straight Connector 71"/>
          <p:cNvSpPr/>
          <p:nvPr/>
        </p:nvSpPr>
        <p:spPr>
          <a:xfrm flipH="1">
            <a:off x="2209680" y="1447920"/>
            <a:ext cx="2895840" cy="7617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Rectangle 314"/>
          <p:cNvSpPr/>
          <p:nvPr/>
        </p:nvSpPr>
        <p:spPr>
          <a:xfrm>
            <a:off x="2137680" y="685800"/>
            <a:ext cx="75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PMM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Rectangle 315"/>
          <p:cNvSpPr/>
          <p:nvPr/>
        </p:nvSpPr>
        <p:spPr>
          <a:xfrm>
            <a:off x="5337720" y="685800"/>
            <a:ext cx="689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宋体"/>
              </a:rPr>
              <a:t>PM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Straight Connector 318"/>
          <p:cNvSpPr/>
          <p:nvPr/>
        </p:nvSpPr>
        <p:spPr>
          <a:xfrm>
            <a:off x="2590200" y="2286000"/>
            <a:ext cx="563400" cy="251460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Straight Connector 320"/>
          <p:cNvSpPr/>
          <p:nvPr/>
        </p:nvSpPr>
        <p:spPr>
          <a:xfrm>
            <a:off x="2590200" y="2286000"/>
            <a:ext cx="2514600" cy="228600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Straight Connector 322"/>
          <p:cNvSpPr/>
          <p:nvPr/>
        </p:nvSpPr>
        <p:spPr>
          <a:xfrm flipH="1">
            <a:off x="3123720" y="1600200"/>
            <a:ext cx="2514600" cy="320040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Straight Connector 324"/>
          <p:cNvSpPr/>
          <p:nvPr/>
        </p:nvSpPr>
        <p:spPr>
          <a:xfrm flipH="1">
            <a:off x="5105160" y="1599480"/>
            <a:ext cx="533160" cy="297180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Straight Connector 326"/>
          <p:cNvSpPr/>
          <p:nvPr/>
        </p:nvSpPr>
        <p:spPr>
          <a:xfrm>
            <a:off x="2590200" y="2286000"/>
            <a:ext cx="3276360" cy="190512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Straight Connector 328"/>
          <p:cNvSpPr/>
          <p:nvPr/>
        </p:nvSpPr>
        <p:spPr>
          <a:xfrm flipH="1">
            <a:off x="2484360" y="2286000"/>
            <a:ext cx="106560" cy="220968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Straight Connector 330"/>
          <p:cNvSpPr/>
          <p:nvPr/>
        </p:nvSpPr>
        <p:spPr>
          <a:xfrm>
            <a:off x="5410080" y="2209680"/>
            <a:ext cx="457200" cy="198144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Straight Connector 332"/>
          <p:cNvSpPr/>
          <p:nvPr/>
        </p:nvSpPr>
        <p:spPr>
          <a:xfrm flipH="1">
            <a:off x="2484000" y="2209680"/>
            <a:ext cx="2925720" cy="228600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Straight Connector 334"/>
          <p:cNvSpPr/>
          <p:nvPr/>
        </p:nvSpPr>
        <p:spPr>
          <a:xfrm>
            <a:off x="3048120" y="1447920"/>
            <a:ext cx="3305160" cy="232416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Straight Connector 336"/>
          <p:cNvSpPr/>
          <p:nvPr/>
        </p:nvSpPr>
        <p:spPr>
          <a:xfrm flipH="1">
            <a:off x="2590920" y="1447920"/>
            <a:ext cx="457200" cy="327636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Straight Connector 355"/>
          <p:cNvSpPr/>
          <p:nvPr/>
        </p:nvSpPr>
        <p:spPr>
          <a:xfrm>
            <a:off x="5637960" y="1599480"/>
            <a:ext cx="714600" cy="217188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Straight Connector 357"/>
          <p:cNvSpPr/>
          <p:nvPr/>
        </p:nvSpPr>
        <p:spPr>
          <a:xfrm flipH="1">
            <a:off x="2590920" y="1600200"/>
            <a:ext cx="3047760" cy="312408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Straight Connector 361"/>
          <p:cNvSpPr/>
          <p:nvPr/>
        </p:nvSpPr>
        <p:spPr>
          <a:xfrm flipH="1">
            <a:off x="2560680" y="2286000"/>
            <a:ext cx="30240" cy="144792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Straight Connector 363"/>
          <p:cNvSpPr/>
          <p:nvPr/>
        </p:nvSpPr>
        <p:spPr>
          <a:xfrm>
            <a:off x="2590200" y="2286000"/>
            <a:ext cx="3762360" cy="148608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Straight Connector 406"/>
          <p:cNvSpPr/>
          <p:nvPr/>
        </p:nvSpPr>
        <p:spPr>
          <a:xfrm>
            <a:off x="5105520" y="1447920"/>
            <a:ext cx="1247760" cy="23241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Straight Connector 408"/>
          <p:cNvSpPr/>
          <p:nvPr/>
        </p:nvSpPr>
        <p:spPr>
          <a:xfrm flipH="1">
            <a:off x="2560320" y="1447920"/>
            <a:ext cx="2544840" cy="228600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Straight Connector 410"/>
          <p:cNvSpPr/>
          <p:nvPr/>
        </p:nvSpPr>
        <p:spPr>
          <a:xfrm>
            <a:off x="2209680" y="2209680"/>
            <a:ext cx="4343400" cy="114300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Straight Connector 466"/>
          <p:cNvSpPr/>
          <p:nvPr/>
        </p:nvSpPr>
        <p:spPr>
          <a:xfrm>
            <a:off x="2209680" y="2209680"/>
            <a:ext cx="381240" cy="251460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Straight Connector 469"/>
          <p:cNvSpPr/>
          <p:nvPr/>
        </p:nvSpPr>
        <p:spPr>
          <a:xfrm>
            <a:off x="2362320" y="1905120"/>
            <a:ext cx="228600" cy="281916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Straight Connector 471"/>
          <p:cNvSpPr/>
          <p:nvPr/>
        </p:nvSpPr>
        <p:spPr>
          <a:xfrm>
            <a:off x="2362320" y="1905120"/>
            <a:ext cx="4343400" cy="144756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Straight Connector 473"/>
          <p:cNvSpPr/>
          <p:nvPr/>
        </p:nvSpPr>
        <p:spPr>
          <a:xfrm>
            <a:off x="2362320" y="1905120"/>
            <a:ext cx="228600" cy="281916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Straight Connector 475"/>
          <p:cNvSpPr/>
          <p:nvPr/>
        </p:nvSpPr>
        <p:spPr>
          <a:xfrm>
            <a:off x="2362320" y="1905120"/>
            <a:ext cx="2514600" cy="289548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Straight Connector 481"/>
          <p:cNvSpPr/>
          <p:nvPr/>
        </p:nvSpPr>
        <p:spPr>
          <a:xfrm flipH="1">
            <a:off x="4876920" y="1600200"/>
            <a:ext cx="761760" cy="320040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Straight Connector 483"/>
          <p:cNvSpPr/>
          <p:nvPr/>
        </p:nvSpPr>
        <p:spPr>
          <a:xfrm flipH="1">
            <a:off x="2590920" y="1600200"/>
            <a:ext cx="3047760" cy="312408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Straight Connector 485"/>
          <p:cNvSpPr/>
          <p:nvPr/>
        </p:nvSpPr>
        <p:spPr>
          <a:xfrm>
            <a:off x="2362320" y="1905120"/>
            <a:ext cx="3990960" cy="186696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Straight Connector 487"/>
          <p:cNvSpPr/>
          <p:nvPr/>
        </p:nvSpPr>
        <p:spPr>
          <a:xfrm>
            <a:off x="2362320" y="1905120"/>
            <a:ext cx="122040" cy="259056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Straight Connector 489"/>
          <p:cNvSpPr/>
          <p:nvPr/>
        </p:nvSpPr>
        <p:spPr>
          <a:xfrm flipH="1">
            <a:off x="2484000" y="1447920"/>
            <a:ext cx="2621160" cy="304776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Straight Connector 491"/>
          <p:cNvSpPr/>
          <p:nvPr/>
        </p:nvSpPr>
        <p:spPr>
          <a:xfrm>
            <a:off x="5105520" y="1447920"/>
            <a:ext cx="1247760" cy="232416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Straight Connector 493"/>
          <p:cNvSpPr/>
          <p:nvPr/>
        </p:nvSpPr>
        <p:spPr>
          <a:xfrm>
            <a:off x="2514600" y="1600200"/>
            <a:ext cx="3838680" cy="217188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Straight Connector 495"/>
          <p:cNvSpPr/>
          <p:nvPr/>
        </p:nvSpPr>
        <p:spPr>
          <a:xfrm>
            <a:off x="2514600" y="1600200"/>
            <a:ext cx="1036800" cy="274320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Straight Connector 497"/>
          <p:cNvSpPr/>
          <p:nvPr/>
        </p:nvSpPr>
        <p:spPr>
          <a:xfrm>
            <a:off x="5943600" y="1905120"/>
            <a:ext cx="409680" cy="186696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Straight Connector 499"/>
          <p:cNvSpPr/>
          <p:nvPr/>
        </p:nvSpPr>
        <p:spPr>
          <a:xfrm flipH="1">
            <a:off x="3551040" y="1904400"/>
            <a:ext cx="2392200" cy="243828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Straight Connector 507"/>
          <p:cNvSpPr/>
          <p:nvPr/>
        </p:nvSpPr>
        <p:spPr>
          <a:xfrm>
            <a:off x="2209680" y="2209680"/>
            <a:ext cx="4496040" cy="129564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Straight Connector 509"/>
          <p:cNvSpPr/>
          <p:nvPr/>
        </p:nvSpPr>
        <p:spPr>
          <a:xfrm>
            <a:off x="2209680" y="2209680"/>
            <a:ext cx="198720" cy="198144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Straight Connector 511"/>
          <p:cNvSpPr/>
          <p:nvPr/>
        </p:nvSpPr>
        <p:spPr>
          <a:xfrm>
            <a:off x="5942880" y="1904400"/>
            <a:ext cx="762120" cy="160020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Straight Connector 514"/>
          <p:cNvSpPr/>
          <p:nvPr/>
        </p:nvSpPr>
        <p:spPr>
          <a:xfrm flipH="1">
            <a:off x="2408400" y="1905120"/>
            <a:ext cx="3535200" cy="228600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Straight Connector 516"/>
          <p:cNvSpPr/>
          <p:nvPr/>
        </p:nvSpPr>
        <p:spPr>
          <a:xfrm flipH="1">
            <a:off x="4876920" y="1600200"/>
            <a:ext cx="761760" cy="320040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Straight Connector 518"/>
          <p:cNvSpPr/>
          <p:nvPr/>
        </p:nvSpPr>
        <p:spPr>
          <a:xfrm flipH="1">
            <a:off x="3153960" y="1600200"/>
            <a:ext cx="2484360" cy="320040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Straight Connector 520"/>
          <p:cNvSpPr/>
          <p:nvPr/>
        </p:nvSpPr>
        <p:spPr>
          <a:xfrm>
            <a:off x="2362320" y="1905120"/>
            <a:ext cx="792000" cy="289548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Straight Connector 523"/>
          <p:cNvSpPr/>
          <p:nvPr/>
        </p:nvSpPr>
        <p:spPr>
          <a:xfrm>
            <a:off x="2362320" y="1905120"/>
            <a:ext cx="2514600" cy="289548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68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4-09T21:49:42Z</dcterms:created>
  <dc:creator>jwang79</dc:creator>
  <dc:description/>
  <dc:language>en-US</dc:language>
  <cp:lastModifiedBy>user</cp:lastModifiedBy>
  <dcterms:modified xsi:type="dcterms:W3CDTF">2012-12-27T12:50:14Z</dcterms:modified>
  <cp:revision>306</cp:revision>
  <dc:subject/>
  <dc:title>Slide 1</dc:title>
</cp:coreProperties>
</file>